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4FE8B-E5A3-4451-BBAA-B7837B16C4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32C78-0EE1-41C0-9C7D-100790C743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0AEDF8-60A1-4D6D-9BD1-411EE69382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33750B-6B4A-4B42-BF7E-D08D5911E5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45F9D-7C72-4413-BA3C-14C8E744E3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30C08C-61EC-4B61-829C-630496C0B2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F723DA-247B-49F0-86C0-AF920AB41D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724C91-071B-4BFC-8EAD-85FFDF2E70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85530-F809-4E51-ACA3-86FAB3AB9C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C7D4C-F679-43C8-A8C3-3EF7FF6B81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156DC5-E4FB-42E3-B469-E5901AA8A4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B8C2A-3BBB-4470-9229-E0306BE1C3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AAE03F-B934-454E-9377-0FEE2771213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635120" y="762120"/>
            <a:ext cx="7315200" cy="51116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10680" y="152280"/>
            <a:ext cx="8567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rmat Required for Raw Data Excel files to Be Used for Conversion Into CRI Fi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Requirements 1, 2, and 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240280" y="5900760"/>
            <a:ext cx="71244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buClr>
                <a:srgbClr val="000000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 spreadsheet with data named Exactly as “WPS”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you can have other sheets in the same Excel file, only th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ne will be taken to be converted from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flipH="1" flipV="1">
            <a:off x="2340000" y="5703480"/>
            <a:ext cx="326880" cy="28404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455840" y="1492200"/>
            <a:ext cx="1111320" cy="45720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3000" y="1179360"/>
            <a:ext cx="1600920" cy="393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.One colum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ith genbank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cess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am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xactly 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nBankID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amed 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nigeneID”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f unigene I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re used; 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amed a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oteinID”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f SwissPro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Ds are used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520" y="5942160"/>
            <a:ext cx="24012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. No cells 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is sheet hav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ore than 255 letter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1-07T22:15:52Z</dcterms:created>
  <dc:creator>MingYi</dc:creator>
  <dc:description/>
  <dc:language>en-US</dc:language>
  <cp:lastModifiedBy>MingYi</cp:lastModifiedBy>
  <dcterms:modified xsi:type="dcterms:W3CDTF">2005-11-08T19:23:35Z</dcterms:modified>
  <cp:revision>11</cp:revision>
  <dc:subject/>
  <dc:title>Slide 1</dc:title>
</cp:coreProperties>
</file>